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-102" y="-55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718797C-F517-4E1E-9C02-0F61536C540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4A1A145A-A50B-4725-AF10-A43403A7F0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F74C9332-2500-41D1-A04C-B860439635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EFF6B-EA7B-46AA-A801-F7C415C76BBC}" type="datetimeFigureOut">
              <a:rPr lang="en-IN" smtClean="0"/>
              <a:pPr/>
              <a:t>18-02-2019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4877805-7024-425B-947F-03FDA97808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BE643DA-835E-4AF2-A0AA-40B6119529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1C5B0-18D3-4116-87F9-6D74A0F3485E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21115745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895BECC-B83C-49F2-973A-246A319479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D8617C6E-41B2-46E7-9ECF-E592257132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5D45D82-F504-4B2C-AD82-0E9A28816B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EFF6B-EA7B-46AA-A801-F7C415C76BBC}" type="datetimeFigureOut">
              <a:rPr lang="en-IN" smtClean="0"/>
              <a:pPr/>
              <a:t>18-02-2019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D36D122-5803-494B-93CA-E0D361CDCF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E32FD9D7-E548-4EC5-A3F4-D98B3A59A0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1C5B0-18D3-4116-87F9-6D74A0F3485E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31804950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E9401277-D4F0-459F-9838-4C020D9AFE7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807E5914-3B72-4AB9-B9CA-CF17A0A12A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20C60D4-33F9-40A2-9C5E-4DF8278B35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EFF6B-EA7B-46AA-A801-F7C415C76BBC}" type="datetimeFigureOut">
              <a:rPr lang="en-IN" smtClean="0"/>
              <a:pPr/>
              <a:t>18-02-2019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8CE25404-1E11-43C6-BB1F-6896E9136A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EAB2BD4-40E7-4909-B805-39AD9721C8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1C5B0-18D3-4116-87F9-6D74A0F3485E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37995432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1164253-A8C6-48BD-9055-C3B22D30F6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7D43030F-06F6-4262-8CA7-3208844277E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229D24E-2A6B-473F-A269-B7F8FBBC8F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EFF6B-EA7B-46AA-A801-F7C415C76BBC}" type="datetimeFigureOut">
              <a:rPr lang="en-IN" smtClean="0"/>
              <a:pPr/>
              <a:t>18-02-2019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C08FC1E2-9C94-490E-BA78-E6778CB8CC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AC13C5C-EF67-4CE4-AEE9-C90CC51C0F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1C5B0-18D3-4116-87F9-6D74A0F3485E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23198267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5712CA1-2BA9-4ED2-959D-6BDA93804E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9306D7CE-367E-4D83-AA03-498707B822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36C6750-2D03-48C4-8929-A2915FBB08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EFF6B-EA7B-46AA-A801-F7C415C76BBC}" type="datetimeFigureOut">
              <a:rPr lang="en-IN" smtClean="0"/>
              <a:pPr/>
              <a:t>18-02-2019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7E19E45E-19DC-46DB-AD71-F64464382C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311185C-EFD9-4228-B596-3288F0E2E3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1C5B0-18D3-4116-87F9-6D74A0F3485E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14536573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FB09E8D-4471-47C7-9A2D-469E17DFF6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0B183A88-8097-43D2-94C0-D095E2840EE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B8E3E8F4-0F2A-4B34-A3DD-64EF204A420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ED4F91C2-580B-4F73-A4AC-F93C4AB717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EFF6B-EA7B-46AA-A801-F7C415C76BBC}" type="datetimeFigureOut">
              <a:rPr lang="en-IN" smtClean="0"/>
              <a:pPr/>
              <a:t>18-02-2019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17C20A8A-0A0C-42E1-BBFE-607D4F4EC7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A4A59037-BBF7-4939-9B3A-E2B106F3DD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1C5B0-18D3-4116-87F9-6D74A0F3485E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600588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1C216A6-A3C6-465B-BE3B-71930C99BC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6118868F-3899-4F15-ACF4-99BF566B07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10D3EEEC-1B10-4772-956D-C5EE08188D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2FCBCB8F-608B-48AE-A445-C8DFE81B81D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10A9EFF4-7ABD-4793-9E3A-DB4E77F1436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D8C57F3E-83CA-4612-A29E-492F8D831A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EFF6B-EA7B-46AA-A801-F7C415C76BBC}" type="datetimeFigureOut">
              <a:rPr lang="en-IN" smtClean="0"/>
              <a:pPr/>
              <a:t>18-02-2019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3DB2705F-9CC4-49C2-B4D2-A803475A79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9A8CE021-BB99-431E-B251-EA2FA04947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1C5B0-18D3-4116-87F9-6D74A0F3485E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30480809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394DC24-0F29-4ABA-A664-89092AC33D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6B999487-A008-4E33-B7D7-7DF4E8193F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EFF6B-EA7B-46AA-A801-F7C415C76BBC}" type="datetimeFigureOut">
              <a:rPr lang="en-IN" smtClean="0"/>
              <a:pPr/>
              <a:t>18-02-2019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E8F3FEB9-388C-4FDC-86FD-4B37EBA46E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6FCE536C-1868-42DD-827F-36B377E3EE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1C5B0-18D3-4116-87F9-6D74A0F3485E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2373489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455C959B-1FB2-4EE7-ADD5-54A9EC5169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EFF6B-EA7B-46AA-A801-F7C415C76BBC}" type="datetimeFigureOut">
              <a:rPr lang="en-IN" smtClean="0"/>
              <a:pPr/>
              <a:t>18-02-2019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4E1C9E46-C470-48F8-A8B6-57EBB6609E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6D006C1B-A36E-494A-8034-BEE24E4CA6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1C5B0-18D3-4116-87F9-6D74A0F3485E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26114786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2DC7811-3B17-4AD9-B7B8-A447AA88B1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0866E09D-4480-4072-A126-D35F1BA5764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3750506E-ABBB-4786-A063-5C56C344D2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CA40A9A4-4C4C-4FF3-B665-951389C83B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EFF6B-EA7B-46AA-A801-F7C415C76BBC}" type="datetimeFigureOut">
              <a:rPr lang="en-IN" smtClean="0"/>
              <a:pPr/>
              <a:t>18-02-2019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E328134D-9D63-4BD5-AF91-3E99A9A9F1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A3726281-7472-47AF-BB39-386D053B18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1C5B0-18D3-4116-87F9-6D74A0F3485E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38772377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8169492-F1AB-4941-AFC7-0704A1BD87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E5D73EC8-2461-4BA3-83B0-BB2CE7F1E9F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237279F9-A31B-460B-BD23-612C7DEA3C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1A78AD35-93FD-446F-8CB1-4EF12F5E1B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EFF6B-EA7B-46AA-A801-F7C415C76BBC}" type="datetimeFigureOut">
              <a:rPr lang="en-IN" smtClean="0"/>
              <a:pPr/>
              <a:t>18-02-2019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20FEAD8F-93F7-4BD6-A8AE-72F7D642E0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092E9387-70C8-43D2-93A0-B852942512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1C5B0-18D3-4116-87F9-6D74A0F3485E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17060476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7F453DCC-4542-410D-B7B2-0B4CB5CC85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32497D55-704D-4019-9CDE-129C626870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6C4FF337-6DF7-4269-BA50-0EBC9F3F748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9EFF6B-EA7B-46AA-A801-F7C415C76BBC}" type="datetimeFigureOut">
              <a:rPr lang="en-IN" smtClean="0"/>
              <a:pPr/>
              <a:t>18-02-2019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7EF87A0D-3FB8-483D-B0DD-4194A01D34A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55CF6AA-90EC-445E-A5AB-E416BCC5CA4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B1C5B0-18D3-4116-87F9-6D74A0F3485E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xmlns="" val="34794673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F490E4E2-6957-408F-A4BD-DE4BA22A44B6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101287" y="735683"/>
            <a:ext cx="6687991" cy="240769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3E9313B4-ABB5-4ED8-9F3F-1C15D68ABAA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2174033" y="3795045"/>
            <a:ext cx="6615245" cy="2671072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xmlns="" id="{BFEAE175-1779-4228-9DE2-FB1FF2D7E2AF}"/>
              </a:ext>
            </a:extLst>
          </p:cNvPr>
          <p:cNvSpPr/>
          <p:nvPr/>
        </p:nvSpPr>
        <p:spPr>
          <a:xfrm>
            <a:off x="1495278" y="-25561"/>
            <a:ext cx="5917069" cy="4633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IN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. Acetic acid tolerant phenotypes in SD medium at 30</a:t>
            </a:r>
            <a:r>
              <a:rPr lang="en-IN" b="1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IN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. </a:t>
            </a:r>
            <a:endParaRPr lang="en-IN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xmlns="" id="{93CBA5E9-8709-4C0E-9FF3-4E8B89130E89}"/>
              </a:ext>
            </a:extLst>
          </p:cNvPr>
          <p:cNvSpPr/>
          <p:nvPr/>
        </p:nvSpPr>
        <p:spPr>
          <a:xfrm>
            <a:off x="1439858" y="3143373"/>
            <a:ext cx="5615640" cy="4633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IN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. Ethanol tolerant phenotypes in SD medium at 30</a:t>
            </a:r>
            <a:r>
              <a:rPr lang="en-IN" b="1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IN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. </a:t>
            </a:r>
            <a:endParaRPr lang="en-IN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BD225F10-8D9D-428A-ABB6-C07F2F699B01}"/>
              </a:ext>
            </a:extLst>
          </p:cNvPr>
          <p:cNvSpPr txBox="1"/>
          <p:nvPr/>
        </p:nvSpPr>
        <p:spPr>
          <a:xfrm>
            <a:off x="9405257" y="6281451"/>
            <a:ext cx="1774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</a:t>
            </a:r>
            <a:r>
              <a:rPr lang="en-IN" b="1">
                <a:latin typeface="Times New Roman" panose="02020603050405020304" pitchFamily="18" charset="0"/>
                <a:cs typeface="Times New Roman" panose="02020603050405020304" pitchFamily="18" charset="0"/>
              </a:rPr>
              <a:t>file </a:t>
            </a:r>
            <a:r>
              <a:rPr lang="en-IN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I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2206051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26</Words>
  <Application>Microsoft Office PowerPoint</Application>
  <PresentationFormat>Custom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JAY KUMAR PANDEY</dc:creator>
  <cp:lastModifiedBy>0013358</cp:lastModifiedBy>
  <cp:revision>3</cp:revision>
  <dcterms:created xsi:type="dcterms:W3CDTF">2019-01-16T03:14:41Z</dcterms:created>
  <dcterms:modified xsi:type="dcterms:W3CDTF">2019-02-18T07:03:43Z</dcterms:modified>
</cp:coreProperties>
</file>